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2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044975C-F375-451A-A6CB-3A78F97F57D6}" v="14" dt="2024-03-15T17:21:34.91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5" autoAdjust="0"/>
    <p:restoredTop sz="94660"/>
  </p:normalViewPr>
  <p:slideViewPr>
    <p:cSldViewPr snapToGrid="0">
      <p:cViewPr varScale="1">
        <p:scale>
          <a:sx n="77" d="100"/>
          <a:sy n="77" d="100"/>
        </p:scale>
        <p:origin x="274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ian Yu" userId="bac6cbed245afebe" providerId="LiveId" clId="{6044975C-F375-451A-A6CB-3A78F97F57D6}"/>
    <pc:docChg chg="custSel addSld delSld modSld sldOrd">
      <pc:chgData name="Jian Yu" userId="bac6cbed245afebe" providerId="LiveId" clId="{6044975C-F375-451A-A6CB-3A78F97F57D6}" dt="2024-03-15T17:26:24.149" v="690" actId="20577"/>
      <pc:docMkLst>
        <pc:docMk/>
      </pc:docMkLst>
      <pc:sldChg chg="del">
        <pc:chgData name="Jian Yu" userId="bac6cbed245afebe" providerId="LiveId" clId="{6044975C-F375-451A-A6CB-3A78F97F57D6}" dt="2024-03-11T19:34:48.345" v="0" actId="2696"/>
        <pc:sldMkLst>
          <pc:docMk/>
          <pc:sldMk cId="2690669846" sldId="261"/>
        </pc:sldMkLst>
      </pc:sldChg>
      <pc:sldChg chg="addSp delSp modSp mod">
        <pc:chgData name="Jian Yu" userId="bac6cbed245afebe" providerId="LiveId" clId="{6044975C-F375-451A-A6CB-3A78F97F57D6}" dt="2024-03-15T17:26:24.149" v="690" actId="20577"/>
        <pc:sldMkLst>
          <pc:docMk/>
          <pc:sldMk cId="3686813601" sldId="262"/>
        </pc:sldMkLst>
        <pc:spChg chg="add mod">
          <ac:chgData name="Jian Yu" userId="bac6cbed245afebe" providerId="LiveId" clId="{6044975C-F375-451A-A6CB-3A78F97F57D6}" dt="2024-03-15T17:26:24.149" v="690" actId="20577"/>
          <ac:spMkLst>
            <pc:docMk/>
            <pc:sldMk cId="3686813601" sldId="262"/>
            <ac:spMk id="3" creationId="{699D4DC7-1DCC-06B8-8CFB-C396F9A9CC16}"/>
          </ac:spMkLst>
        </pc:spChg>
        <pc:spChg chg="mod">
          <ac:chgData name="Jian Yu" userId="bac6cbed245afebe" providerId="LiveId" clId="{6044975C-F375-451A-A6CB-3A78F97F57D6}" dt="2024-03-15T17:26:18.717" v="688" actId="1076"/>
          <ac:spMkLst>
            <pc:docMk/>
            <pc:sldMk cId="3686813601" sldId="262"/>
            <ac:spMk id="5" creationId="{B33472EA-D260-33C1-48D2-48BBD685B13E}"/>
          </ac:spMkLst>
        </pc:spChg>
        <pc:spChg chg="mod">
          <ac:chgData name="Jian Yu" userId="bac6cbed245afebe" providerId="LiveId" clId="{6044975C-F375-451A-A6CB-3A78F97F57D6}" dt="2024-03-15T17:23:05.554" v="652" actId="14100"/>
          <ac:spMkLst>
            <pc:docMk/>
            <pc:sldMk cId="3686813601" sldId="262"/>
            <ac:spMk id="6" creationId="{A3598AB2-AC52-EB9B-7A44-FED4E1D71CCF}"/>
          </ac:spMkLst>
        </pc:spChg>
        <pc:spChg chg="add del mod">
          <ac:chgData name="Jian Yu" userId="bac6cbed245afebe" providerId="LiveId" clId="{6044975C-F375-451A-A6CB-3A78F97F57D6}" dt="2024-03-15T17:24:29.190" v="668"/>
          <ac:spMkLst>
            <pc:docMk/>
            <pc:sldMk cId="3686813601" sldId="262"/>
            <ac:spMk id="8" creationId="{B61B982D-B14B-9470-9EF4-132A21E5A949}"/>
          </ac:spMkLst>
        </pc:spChg>
        <pc:spChg chg="add del mod">
          <ac:chgData name="Jian Yu" userId="bac6cbed245afebe" providerId="LiveId" clId="{6044975C-F375-451A-A6CB-3A78F97F57D6}" dt="2024-03-15T17:24:36.302" v="673" actId="478"/>
          <ac:spMkLst>
            <pc:docMk/>
            <pc:sldMk cId="3686813601" sldId="262"/>
            <ac:spMk id="10" creationId="{F6ACF43F-31A2-29DF-B112-5CDD5D842DC1}"/>
          </ac:spMkLst>
        </pc:spChg>
        <pc:picChg chg="mod">
          <ac:chgData name="Jian Yu" userId="bac6cbed245afebe" providerId="LiveId" clId="{6044975C-F375-451A-A6CB-3A78F97F57D6}" dt="2024-03-15T17:22:47.764" v="650" actId="1076"/>
          <ac:picMkLst>
            <pc:docMk/>
            <pc:sldMk cId="3686813601" sldId="262"/>
            <ac:picMk id="4" creationId="{2876C6C4-D937-DF5A-C5B9-69EF4AFA6031}"/>
          </ac:picMkLst>
        </pc:picChg>
      </pc:sldChg>
      <pc:sldChg chg="addSp delSp modSp new del mod ord">
        <pc:chgData name="Jian Yu" userId="bac6cbed245afebe" providerId="LiveId" clId="{6044975C-F375-451A-A6CB-3A78F97F57D6}" dt="2024-03-15T17:20:04.433" v="513" actId="2696"/>
        <pc:sldMkLst>
          <pc:docMk/>
          <pc:sldMk cId="1969441991" sldId="263"/>
        </pc:sldMkLst>
        <pc:spChg chg="del">
          <ac:chgData name="Jian Yu" userId="bac6cbed245afebe" providerId="LiveId" clId="{6044975C-F375-451A-A6CB-3A78F97F57D6}" dt="2024-03-15T17:18:55.036" v="498" actId="478"/>
          <ac:spMkLst>
            <pc:docMk/>
            <pc:sldMk cId="1969441991" sldId="263"/>
            <ac:spMk id="2" creationId="{A94B98F4-AD7A-8C3D-50C0-AEEC11D14388}"/>
          </ac:spMkLst>
        </pc:spChg>
        <pc:spChg chg="del">
          <ac:chgData name="Jian Yu" userId="bac6cbed245afebe" providerId="LiveId" clId="{6044975C-F375-451A-A6CB-3A78F97F57D6}" dt="2024-03-15T17:18:56.172" v="499" actId="478"/>
          <ac:spMkLst>
            <pc:docMk/>
            <pc:sldMk cId="1969441991" sldId="263"/>
            <ac:spMk id="3" creationId="{92AC409B-0A68-48E2-6F4D-67E02B98D6A6}"/>
          </ac:spMkLst>
        </pc:spChg>
        <pc:spChg chg="add mod">
          <ac:chgData name="Jian Yu" userId="bac6cbed245afebe" providerId="LiveId" clId="{6044975C-F375-451A-A6CB-3A78F97F57D6}" dt="2024-03-15T17:19:02.852" v="501" actId="20577"/>
          <ac:spMkLst>
            <pc:docMk/>
            <pc:sldMk cId="1969441991" sldId="263"/>
            <ac:spMk id="4" creationId="{B897C051-6A10-6E4A-7D87-36DA6F2B160E}"/>
          </ac:spMkLst>
        </pc:spChg>
        <pc:spChg chg="add mod">
          <ac:chgData name="Jian Yu" userId="bac6cbed245afebe" providerId="LiveId" clId="{6044975C-F375-451A-A6CB-3A78F97F57D6}" dt="2024-03-15T17:19:34.733" v="509" actId="20577"/>
          <ac:spMkLst>
            <pc:docMk/>
            <pc:sldMk cId="1969441991" sldId="263"/>
            <ac:spMk id="5" creationId="{DFA9501F-D2B8-8348-7E73-83B82FBFAF71}"/>
          </ac:spMkLst>
        </pc:spChg>
      </pc:sldChg>
      <pc:sldChg chg="addSp delSp modSp new del mod">
        <pc:chgData name="Jian Yu" userId="bac6cbed245afebe" providerId="LiveId" clId="{6044975C-F375-451A-A6CB-3A78F97F57D6}" dt="2024-03-15T17:18:24.328" v="494" actId="2696"/>
        <pc:sldMkLst>
          <pc:docMk/>
          <pc:sldMk cId="3014967767" sldId="263"/>
        </pc:sldMkLst>
        <pc:spChg chg="mod">
          <ac:chgData name="Jian Yu" userId="bac6cbed245afebe" providerId="LiveId" clId="{6044975C-F375-451A-A6CB-3A78F97F57D6}" dt="2024-03-12T23:15:04.981" v="493" actId="20577"/>
          <ac:spMkLst>
            <pc:docMk/>
            <pc:sldMk cId="3014967767" sldId="263"/>
            <ac:spMk id="2" creationId="{AD6DC59D-36D4-9B32-3543-1346AEA0C7F7}"/>
          </ac:spMkLst>
        </pc:spChg>
        <pc:spChg chg="del">
          <ac:chgData name="Jian Yu" userId="bac6cbed245afebe" providerId="LiveId" clId="{6044975C-F375-451A-A6CB-3A78F97F57D6}" dt="2024-03-12T22:58:59.035" v="435"/>
          <ac:spMkLst>
            <pc:docMk/>
            <pc:sldMk cId="3014967767" sldId="263"/>
            <ac:spMk id="3" creationId="{614DF271-D4CA-F04D-056A-F4ADEAB6B037}"/>
          </ac:spMkLst>
        </pc:spChg>
        <pc:spChg chg="add del mod">
          <ac:chgData name="Jian Yu" userId="bac6cbed245afebe" providerId="LiveId" clId="{6044975C-F375-451A-A6CB-3A78F97F57D6}" dt="2024-03-12T23:14:08.178" v="438"/>
          <ac:spMkLst>
            <pc:docMk/>
            <pc:sldMk cId="3014967767" sldId="263"/>
            <ac:spMk id="6" creationId="{E8539854-6288-BDEC-C9CF-6BC33F9952C0}"/>
          </ac:spMkLst>
        </pc:spChg>
        <pc:graphicFrameChg chg="add del mod">
          <ac:chgData name="Jian Yu" userId="bac6cbed245afebe" providerId="LiveId" clId="{6044975C-F375-451A-A6CB-3A78F97F57D6}" dt="2024-03-12T23:14:06.214" v="437" actId="478"/>
          <ac:graphicFrameMkLst>
            <pc:docMk/>
            <pc:sldMk cId="3014967767" sldId="263"/>
            <ac:graphicFrameMk id="4" creationId="{DB9D8136-BC49-455E-9477-2FEBC326ACEB}"/>
          </ac:graphicFrameMkLst>
        </pc:graphicFrameChg>
        <pc:graphicFrameChg chg="add mod">
          <ac:chgData name="Jian Yu" userId="bac6cbed245afebe" providerId="LiveId" clId="{6044975C-F375-451A-A6CB-3A78F97F57D6}" dt="2024-03-12T23:14:39.512" v="471" actId="1076"/>
          <ac:graphicFrameMkLst>
            <pc:docMk/>
            <pc:sldMk cId="3014967767" sldId="263"/>
            <ac:graphicFrameMk id="7" creationId="{DB9D8136-BC49-455E-9477-2FEBC326ACEB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F4147-8963-4155-BB64-E57BDDF7EB2C}" type="datetimeFigureOut">
              <a:rPr lang="en-US" smtClean="0"/>
              <a:t>3/1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B3A03-5A0C-456A-95F0-395A143C84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8643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F4147-8963-4155-BB64-E57BDDF7EB2C}" type="datetimeFigureOut">
              <a:rPr lang="en-US" smtClean="0"/>
              <a:t>3/1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B3A03-5A0C-456A-95F0-395A143C84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62907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F4147-8963-4155-BB64-E57BDDF7EB2C}" type="datetimeFigureOut">
              <a:rPr lang="en-US" smtClean="0"/>
              <a:t>3/1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B3A03-5A0C-456A-95F0-395A143C84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04032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F4147-8963-4155-BB64-E57BDDF7EB2C}" type="datetimeFigureOut">
              <a:rPr lang="en-US" smtClean="0"/>
              <a:t>3/1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B3A03-5A0C-456A-95F0-395A143C84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74620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F4147-8963-4155-BB64-E57BDDF7EB2C}" type="datetimeFigureOut">
              <a:rPr lang="en-US" smtClean="0"/>
              <a:t>3/1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B3A03-5A0C-456A-95F0-395A143C84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81078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F4147-8963-4155-BB64-E57BDDF7EB2C}" type="datetimeFigureOut">
              <a:rPr lang="en-US" smtClean="0"/>
              <a:t>3/1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B3A03-5A0C-456A-95F0-395A143C84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61439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F4147-8963-4155-BB64-E57BDDF7EB2C}" type="datetimeFigureOut">
              <a:rPr lang="en-US" smtClean="0"/>
              <a:t>3/15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B3A03-5A0C-456A-95F0-395A143C84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26572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F4147-8963-4155-BB64-E57BDDF7EB2C}" type="datetimeFigureOut">
              <a:rPr lang="en-US" smtClean="0"/>
              <a:t>3/15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B3A03-5A0C-456A-95F0-395A143C84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69272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F4147-8963-4155-BB64-E57BDDF7EB2C}" type="datetimeFigureOut">
              <a:rPr lang="en-US" smtClean="0"/>
              <a:t>3/15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B3A03-5A0C-456A-95F0-395A143C84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73385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F4147-8963-4155-BB64-E57BDDF7EB2C}" type="datetimeFigureOut">
              <a:rPr lang="en-US" smtClean="0"/>
              <a:t>3/1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B3A03-5A0C-456A-95F0-395A143C84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8130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F4147-8963-4155-BB64-E57BDDF7EB2C}" type="datetimeFigureOut">
              <a:rPr lang="en-US" smtClean="0"/>
              <a:t>3/1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B3A03-5A0C-456A-95F0-395A143C84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17775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8F4147-8963-4155-BB64-E57BDDF7EB2C}" type="datetimeFigureOut">
              <a:rPr lang="en-US" smtClean="0"/>
              <a:t>3/1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DB3A03-5A0C-456A-95F0-395A143C84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41154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2876C6C4-D937-DF5A-C5B9-69EF4AFA6031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602187" y="1903956"/>
            <a:ext cx="5304082" cy="2179571"/>
          </a:xfrm>
          <a:prstGeom prst="rect">
            <a:avLst/>
          </a:prstGeom>
        </p:spPr>
      </p:pic>
      <p:sp>
        <p:nvSpPr>
          <p:cNvPr id="5" name="Title 1">
            <a:extLst>
              <a:ext uri="{FF2B5EF4-FFF2-40B4-BE49-F238E27FC236}">
                <a16:creationId xmlns:a16="http://schemas.microsoft.com/office/drawing/2014/main" id="{B33472EA-D260-33C1-48D2-48BBD685B13E}"/>
              </a:ext>
            </a:extLst>
          </p:cNvPr>
          <p:cNvSpPr txBox="1">
            <a:spLocks/>
          </p:cNvSpPr>
          <p:nvPr/>
        </p:nvSpPr>
        <p:spPr>
          <a:xfrm>
            <a:off x="667537" y="4484340"/>
            <a:ext cx="5522926" cy="864295"/>
          </a:xfrm>
          <a:prstGeom prst="rect">
            <a:avLst/>
          </a:prstGeom>
        </p:spPr>
        <p:txBody>
          <a:bodyPr vert="horz" lIns="51435" tIns="25718" rIns="51435" bIns="25718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400" dirty="0">
                <a:latin typeface="AdvP403A40"/>
              </a:rPr>
              <a:t>Figure 6 (B) Correction.  Sunitinib induced PUMA in xenograft tumors. The levels of indicated proteins in 8 randomly selected WT tumors were detected by Western blotting. Tumors were analyzed 24 hours after the third injection.</a:t>
            </a:r>
          </a:p>
          <a:p>
            <a:pPr algn="l"/>
            <a:endParaRPr lang="en-US" sz="1400" dirty="0">
              <a:latin typeface="AdvP403A40"/>
            </a:endParaRPr>
          </a:p>
        </p:txBody>
      </p:sp>
      <p:sp>
        <p:nvSpPr>
          <p:cNvPr id="6" name="Title 1">
            <a:extLst>
              <a:ext uri="{FF2B5EF4-FFF2-40B4-BE49-F238E27FC236}">
                <a16:creationId xmlns:a16="http://schemas.microsoft.com/office/drawing/2014/main" id="{A3598AB2-AC52-EB9B-7A44-FED4E1D71C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7" y="753518"/>
            <a:ext cx="5653626" cy="624345"/>
          </a:xfrm>
        </p:spPr>
        <p:txBody>
          <a:bodyPr/>
          <a:lstStyle/>
          <a:p>
            <a:r>
              <a:rPr lang="en-US" dirty="0"/>
              <a:t>Fig 6B Correction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99D4DC7-1DCC-06B8-8CFB-C396F9A9CC16}"/>
              </a:ext>
            </a:extLst>
          </p:cNvPr>
          <p:cNvSpPr txBox="1"/>
          <p:nvPr/>
        </p:nvSpPr>
        <p:spPr>
          <a:xfrm>
            <a:off x="667537" y="5424163"/>
            <a:ext cx="5522926" cy="18158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dirty="0"/>
              <a:t>Correction notes</a:t>
            </a:r>
            <a:br>
              <a:rPr lang="en-US" sz="1400" dirty="0"/>
            </a:br>
            <a:r>
              <a:rPr lang="fr-FR" sz="1400" dirty="0"/>
              <a:t>Article ID 10.1371/journal.pone.004318</a:t>
            </a:r>
          </a:p>
          <a:p>
            <a:endParaRPr lang="fr-FR" sz="1400" dirty="0"/>
          </a:p>
          <a:p>
            <a:r>
              <a:rPr lang="en-US" sz="1400" dirty="0"/>
              <a:t>We are very sorry for the error made during manuscript preparation. The inadvertent side by side duplication of the Mcl-1 blot did not change the conclusion.  The experiment has now been repeated, confirming marked induction of PUMA and loss of Mcl-1 proteins.</a:t>
            </a:r>
          </a:p>
          <a:p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36868136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90</TotalTime>
  <Words>102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dvP403A40</vt:lpstr>
      <vt:lpstr>Arial</vt:lpstr>
      <vt:lpstr>Calibri</vt:lpstr>
      <vt:lpstr>Calibri Light</vt:lpstr>
      <vt:lpstr>Office Theme</vt:lpstr>
      <vt:lpstr>Fig 6B Correc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224 0118 quanhong</dc:title>
  <dc:creator>Jian Yu</dc:creator>
  <cp:lastModifiedBy>Jian Yu</cp:lastModifiedBy>
  <cp:revision>4</cp:revision>
  <dcterms:created xsi:type="dcterms:W3CDTF">2024-01-19T18:53:00Z</dcterms:created>
  <dcterms:modified xsi:type="dcterms:W3CDTF">2024-03-15T17:26:29Z</dcterms:modified>
</cp:coreProperties>
</file>